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8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1DF09-7A4A-471F-958E-BEA6DBF4CF08}" type="datetimeFigureOut">
              <a:rPr kumimoji="1" lang="ja-JP" altLang="en-US" smtClean="0"/>
              <a:t>2023/2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28890F-207D-4082-AEB3-F099F394BE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7117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28890F-207D-4082-AEB3-F099F394BE4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390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11AF0-2C22-C7ED-A25E-B10296DFFE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59FCBF-27D2-ED3F-E0AF-0FA92E48D8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BDE88-DBA8-3174-0841-A542498A8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8D20A1-8894-E955-5AA2-632F8874A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DE7B50-66F1-2249-958D-FABFC7DA7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740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39C09-A53E-5329-27E7-9604482BAA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3A7213-EE15-02E0-2FC9-48524900F6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623DC1-949C-D859-1AD1-6724A176E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03CC63-9075-54D9-B29F-E92B219B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53917-BD9A-8DA0-F05E-C87AC09AD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364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6ED54A-8980-E553-105B-4B1F532642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6BB2AA-CCD5-33A3-BC4C-4E88768996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CA7AF1-DDD9-055E-D5F0-7AED84D2F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A57EBD-8879-597C-EEFC-AD8CE9B8D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29F033-7AB9-8D10-1997-E906A6633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7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91443C-C2C4-9106-2C8F-72A2D6208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70E9D0-7F67-6685-BDEC-F8542B7668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54242E-36DB-717F-FB92-A5A6C41A0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A1656D-675C-DD98-1289-46D6A4DCB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884AAF-316B-8605-C669-4808146EF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73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A29FF-E0B7-6443-64DF-F9CCE2292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F10561-5032-50F2-BB6D-17C46C6B5C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4D5624-DFA5-7ADB-8DFB-F8262F592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713638-7226-9DA7-6A0F-4CC922336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94CD42-67D8-0061-8F79-C6A52E9E1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935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2731A-A4B0-F3CB-3619-F25CD9D4C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A86453-972C-102D-C534-3011D6B02B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902246-96F9-F233-BB5E-0373842CDD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98F037-1E7F-1D7E-BCC3-6BB7242E4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A773B6-E3E0-9867-2C79-8B0AF1A10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E26CB6-9AFD-0F38-6C36-F3134473E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241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CC490-1920-49C6-E2BC-A0A84AD2B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EB7F9E-400C-D770-3801-7537C08FF5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58339B-C60C-71B1-300D-2F382D0168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6F661B-7AB9-1C54-5D54-1ECB799C2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BC7129-7C1D-8E32-C580-2C28488F39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765896-B4FC-9DE5-3C74-D01F34F7A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913BDD-BA44-26DA-51D1-F3D2CA0E0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698A19-CC79-8D5A-34C8-B472B925D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287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BB352E-E4C3-11A7-1E45-8C17EB231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DE4F9D-119C-96E8-EEE8-6432FC1D9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813EF5-CE85-1D8D-3128-D08533458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FB7B54-4356-6AEB-1104-0B4543228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027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BD8E7B-01F5-F4C3-3A0F-304E0A65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199CCF-735A-BE62-9406-5B15966A7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304483-0728-DE1C-CB54-9CC648706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43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C52EF-6F42-A745-2734-57BFC2994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9353EE-65D3-A488-6C68-5C532735D7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ADF335-91EE-C6F2-6AF6-921479E227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1CB152-20CE-1AF9-181D-4A46116C1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583D2B-CCDC-DE33-328D-14EC5A403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0B0F5C-BECC-9FBC-57FC-A26C5AE39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777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DC984-602C-81C5-2CD4-424DC81B1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203397-EBA7-8BB3-9D97-D474EFE353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DFC22F-9AA0-0187-6CD0-6D8A98CD27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49B5ED-6197-B437-0FA1-810F7905A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071B27-5860-02F2-8491-6C7591E86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FFE343-18B1-B2B7-4C3E-C3BD0098B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302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52E0B6-AFC5-B21C-88A1-E0AA1054B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62E921-A9B2-102F-B218-837ED98E48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55593-1A0D-966B-A347-B94C835310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F738C-2CAE-41A4-9CE7-FE2D6F89A406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E2BE29-470F-E906-2B70-4F5CCA2DA0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13568E-1ED0-BC7C-95B0-569C6B3BC6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A8DC3-E70E-4700-8B1B-00A701BE90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584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/>
          <p:cNvGrpSpPr/>
          <p:nvPr/>
        </p:nvGrpSpPr>
        <p:grpSpPr>
          <a:xfrm>
            <a:off x="1074544" y="242803"/>
            <a:ext cx="9329295" cy="4908318"/>
            <a:chOff x="1074544" y="649202"/>
            <a:chExt cx="9094445" cy="5692973"/>
          </a:xfrm>
        </p:grpSpPr>
        <p:grpSp>
          <p:nvGrpSpPr>
            <p:cNvPr id="43" name="グループ化 42"/>
            <p:cNvGrpSpPr/>
            <p:nvPr/>
          </p:nvGrpSpPr>
          <p:grpSpPr>
            <a:xfrm>
              <a:off x="4504261" y="1976724"/>
              <a:ext cx="3549262" cy="903251"/>
              <a:chOff x="1809817" y="763865"/>
              <a:chExt cx="3549262" cy="903251"/>
            </a:xfrm>
          </p:grpSpPr>
          <p:sp>
            <p:nvSpPr>
              <p:cNvPr id="44" name="正方形/長方形 43"/>
              <p:cNvSpPr/>
              <p:nvPr/>
            </p:nvSpPr>
            <p:spPr>
              <a:xfrm>
                <a:off x="1809817" y="763865"/>
                <a:ext cx="3549262" cy="903251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/>
              </a:p>
            </p:txBody>
          </p:sp>
          <p:cxnSp>
            <p:nvCxnSpPr>
              <p:cNvPr id="45" name="直線コネクタ 44"/>
              <p:cNvCxnSpPr/>
              <p:nvPr/>
            </p:nvCxnSpPr>
            <p:spPr>
              <a:xfrm flipH="1">
                <a:off x="2976859" y="763865"/>
                <a:ext cx="1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線コネクタ 45"/>
              <p:cNvCxnSpPr/>
              <p:nvPr/>
            </p:nvCxnSpPr>
            <p:spPr>
              <a:xfrm>
                <a:off x="4164752" y="763865"/>
                <a:ext cx="0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正方形/長方形 46"/>
              <p:cNvSpPr/>
              <p:nvPr/>
            </p:nvSpPr>
            <p:spPr>
              <a:xfrm>
                <a:off x="1809817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  <p:sp>
            <p:nvSpPr>
              <p:cNvPr id="48" name="正方形/長方形 47"/>
              <p:cNvSpPr/>
              <p:nvPr/>
            </p:nvSpPr>
            <p:spPr>
              <a:xfrm>
                <a:off x="4868138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</p:grpSp>
        <p:pic>
          <p:nvPicPr>
            <p:cNvPr id="1026" name="Picture 2" descr="Пробирки, Масштаб, Лаборатория, Науки, Химия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8818297">
              <a:off x="7696718" y="2439615"/>
              <a:ext cx="264443" cy="4032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6" name="グループ化 35"/>
            <p:cNvGrpSpPr/>
            <p:nvPr/>
          </p:nvGrpSpPr>
          <p:grpSpPr>
            <a:xfrm>
              <a:off x="4575508" y="678203"/>
              <a:ext cx="3549262" cy="903251"/>
              <a:chOff x="1809817" y="763865"/>
              <a:chExt cx="3549262" cy="903251"/>
            </a:xfrm>
          </p:grpSpPr>
          <p:sp>
            <p:nvSpPr>
              <p:cNvPr id="4" name="正方形/長方形 3"/>
              <p:cNvSpPr/>
              <p:nvPr/>
            </p:nvSpPr>
            <p:spPr>
              <a:xfrm>
                <a:off x="1809817" y="763865"/>
                <a:ext cx="3549262" cy="903251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/>
              </a:p>
            </p:txBody>
          </p:sp>
          <p:cxnSp>
            <p:nvCxnSpPr>
              <p:cNvPr id="6" name="直線コネクタ 5"/>
              <p:cNvCxnSpPr/>
              <p:nvPr/>
            </p:nvCxnSpPr>
            <p:spPr>
              <a:xfrm flipH="1">
                <a:off x="2976859" y="763865"/>
                <a:ext cx="1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コネクタ 7"/>
              <p:cNvCxnSpPr/>
              <p:nvPr/>
            </p:nvCxnSpPr>
            <p:spPr>
              <a:xfrm>
                <a:off x="4164752" y="763865"/>
                <a:ext cx="0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正方形/長方形 14"/>
              <p:cNvSpPr/>
              <p:nvPr/>
            </p:nvSpPr>
            <p:spPr>
              <a:xfrm>
                <a:off x="1809817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  <p:sp>
            <p:nvSpPr>
              <p:cNvPr id="30" name="正方形/長方形 29"/>
              <p:cNvSpPr/>
              <p:nvPr/>
            </p:nvSpPr>
            <p:spPr>
              <a:xfrm>
                <a:off x="4868138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</p:grpSp>
        <p:pic>
          <p:nvPicPr>
            <p:cNvPr id="18" name="図 1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47777" y="816945"/>
              <a:ext cx="487398" cy="487398"/>
            </a:xfrm>
            <a:prstGeom prst="rect">
              <a:avLst/>
            </a:prstGeom>
          </p:spPr>
        </p:pic>
        <p:sp>
          <p:nvSpPr>
            <p:cNvPr id="20" name="テキスト ボックス 19"/>
            <p:cNvSpPr txBox="1"/>
            <p:nvPr/>
          </p:nvSpPr>
          <p:spPr>
            <a:xfrm>
              <a:off x="1108696" y="867830"/>
              <a:ext cx="238988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solidFill>
                    <a:srgbClr val="FF0000"/>
                  </a:solidFill>
                </a:rPr>
                <a:t>Habituation</a:t>
              </a:r>
              <a:r>
                <a:rPr kumimoji="1" lang="en-US" altLang="ja-JP" b="1" dirty="0"/>
                <a:t>: 10 min in </a:t>
              </a:r>
            </a:p>
            <a:p>
              <a:r>
                <a:rPr kumimoji="1" lang="en-US" altLang="ja-JP" b="1" dirty="0"/>
                <a:t>empty chamber</a:t>
              </a:r>
              <a:endParaRPr kumimoji="1" lang="ja-JP" altLang="en-US" b="1" dirty="0"/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6954514" y="649202"/>
              <a:ext cx="135863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/>
                <a:t>Stranger 2-3</a:t>
              </a:r>
            </a:p>
            <a:p>
              <a:r>
                <a:rPr lang="en-US" altLang="ja-JP" sz="1400" b="1" dirty="0"/>
                <a:t> or object zone </a:t>
              </a:r>
              <a:endParaRPr kumimoji="1" lang="ja-JP" altLang="en-US" sz="1400" b="1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469287" y="692802"/>
              <a:ext cx="15680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/>
                <a:t>Stranger 1 zone </a:t>
              </a:r>
              <a:endParaRPr kumimoji="1" lang="ja-JP" altLang="en-US" sz="1400" b="1" dirty="0"/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8209559" y="1103410"/>
              <a:ext cx="195943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2-3 cage </a:t>
              </a:r>
            </a:p>
            <a:p>
              <a:r>
                <a:rPr kumimoji="1" lang="en-US" altLang="ja-JP" sz="1600" b="1" dirty="0"/>
                <a:t>or object place</a:t>
              </a:r>
              <a:endParaRPr kumimoji="1" lang="ja-JP" altLang="en-US" sz="1600" b="1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376690" y="1120584"/>
              <a:ext cx="114015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1 cage</a:t>
              </a:r>
              <a:endParaRPr kumimoji="1" lang="ja-JP" altLang="en-US" sz="1600" b="1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093858" y="2233111"/>
              <a:ext cx="2260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solidFill>
                    <a:srgbClr val="FF0000"/>
                  </a:solidFill>
                </a:rPr>
                <a:t>Sociability</a:t>
              </a:r>
              <a:r>
                <a:rPr kumimoji="1" lang="en-US" altLang="ja-JP" b="1" dirty="0"/>
                <a:t>: 5 min</a:t>
              </a:r>
              <a:endParaRPr kumimoji="1" lang="ja-JP" altLang="en-US" b="1" dirty="0"/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3412658" y="2516970"/>
              <a:ext cx="1043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1</a:t>
              </a:r>
              <a:endParaRPr kumimoji="1" lang="ja-JP" altLang="en-US" sz="1600" b="1" dirty="0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8162043" y="2520855"/>
              <a:ext cx="12354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Object place</a:t>
              </a:r>
              <a:endParaRPr kumimoji="1" lang="ja-JP" altLang="en-US" sz="1600" b="1" dirty="0"/>
            </a:p>
          </p:txBody>
        </p:sp>
        <p:cxnSp>
          <p:nvCxnSpPr>
            <p:cNvPr id="9" name="直線矢印コネクタ 8"/>
            <p:cNvCxnSpPr/>
            <p:nvPr/>
          </p:nvCxnSpPr>
          <p:spPr>
            <a:xfrm flipH="1">
              <a:off x="6291476" y="1579544"/>
              <a:ext cx="1900" cy="36155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9" name="グループ化 48"/>
            <p:cNvGrpSpPr/>
            <p:nvPr/>
          </p:nvGrpSpPr>
          <p:grpSpPr>
            <a:xfrm>
              <a:off x="4504261" y="3360982"/>
              <a:ext cx="3549262" cy="903251"/>
              <a:chOff x="1809817" y="763865"/>
              <a:chExt cx="3549262" cy="903251"/>
            </a:xfrm>
          </p:grpSpPr>
          <p:sp>
            <p:nvSpPr>
              <p:cNvPr id="50" name="正方形/長方形 49"/>
              <p:cNvSpPr/>
              <p:nvPr/>
            </p:nvSpPr>
            <p:spPr>
              <a:xfrm>
                <a:off x="1809817" y="763865"/>
                <a:ext cx="3549262" cy="903251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/>
              </a:p>
            </p:txBody>
          </p:sp>
          <p:cxnSp>
            <p:nvCxnSpPr>
              <p:cNvPr id="51" name="直線コネクタ 50"/>
              <p:cNvCxnSpPr/>
              <p:nvPr/>
            </p:nvCxnSpPr>
            <p:spPr>
              <a:xfrm flipH="1">
                <a:off x="2976859" y="763865"/>
                <a:ext cx="1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/>
              <p:cNvCxnSpPr/>
              <p:nvPr/>
            </p:nvCxnSpPr>
            <p:spPr>
              <a:xfrm>
                <a:off x="4164752" y="763865"/>
                <a:ext cx="0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正方形/長方形 52"/>
              <p:cNvSpPr/>
              <p:nvPr/>
            </p:nvSpPr>
            <p:spPr>
              <a:xfrm>
                <a:off x="1809817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  <p:sp>
            <p:nvSpPr>
              <p:cNvPr id="54" name="正方形/長方形 53"/>
              <p:cNvSpPr/>
              <p:nvPr/>
            </p:nvSpPr>
            <p:spPr>
              <a:xfrm>
                <a:off x="4868138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</p:grpSp>
        <p:grpSp>
          <p:nvGrpSpPr>
            <p:cNvPr id="55" name="グループ化 54"/>
            <p:cNvGrpSpPr/>
            <p:nvPr/>
          </p:nvGrpSpPr>
          <p:grpSpPr>
            <a:xfrm>
              <a:off x="4504261" y="5176186"/>
              <a:ext cx="3549262" cy="903251"/>
              <a:chOff x="1809817" y="763865"/>
              <a:chExt cx="3549262" cy="903251"/>
            </a:xfrm>
          </p:grpSpPr>
          <p:sp>
            <p:nvSpPr>
              <p:cNvPr id="56" name="正方形/長方形 55"/>
              <p:cNvSpPr/>
              <p:nvPr/>
            </p:nvSpPr>
            <p:spPr>
              <a:xfrm>
                <a:off x="1809817" y="763865"/>
                <a:ext cx="3549262" cy="903251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 dirty="0"/>
              </a:p>
            </p:txBody>
          </p:sp>
          <p:cxnSp>
            <p:nvCxnSpPr>
              <p:cNvPr id="57" name="直線コネクタ 56"/>
              <p:cNvCxnSpPr/>
              <p:nvPr/>
            </p:nvCxnSpPr>
            <p:spPr>
              <a:xfrm flipH="1">
                <a:off x="2976859" y="763865"/>
                <a:ext cx="1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/>
              <p:cNvCxnSpPr/>
              <p:nvPr/>
            </p:nvCxnSpPr>
            <p:spPr>
              <a:xfrm>
                <a:off x="4164752" y="763865"/>
                <a:ext cx="0" cy="9032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正方形/長方形 58"/>
              <p:cNvSpPr/>
              <p:nvPr/>
            </p:nvSpPr>
            <p:spPr>
              <a:xfrm>
                <a:off x="1809817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  <p:sp>
            <p:nvSpPr>
              <p:cNvPr id="60" name="正方形/長方形 59"/>
              <p:cNvSpPr/>
              <p:nvPr/>
            </p:nvSpPr>
            <p:spPr>
              <a:xfrm>
                <a:off x="4868138" y="1227137"/>
                <a:ext cx="490941" cy="439979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b="1"/>
              </a:p>
            </p:txBody>
          </p:sp>
        </p:grpSp>
        <p:pic>
          <p:nvPicPr>
            <p:cNvPr id="61" name="図 60"/>
            <p:cNvPicPr>
              <a:picLocks noChangeAspect="1"/>
            </p:cNvPicPr>
            <p:nvPr/>
          </p:nvPicPr>
          <p:blipFill rotWithShape="1">
            <a:blip r:embed="rId4"/>
            <a:srcRect l="5716" t="6345" r="6830" b="10111"/>
            <a:stretch/>
          </p:blipFill>
          <p:spPr>
            <a:xfrm>
              <a:off x="4533949" y="2449029"/>
              <a:ext cx="426245" cy="407194"/>
            </a:xfrm>
            <a:prstGeom prst="rect">
              <a:avLst/>
            </a:prstGeom>
          </p:spPr>
        </p:pic>
        <p:pic>
          <p:nvPicPr>
            <p:cNvPr id="62" name="図 6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21551" y="2216296"/>
              <a:ext cx="487398" cy="487398"/>
            </a:xfrm>
            <a:prstGeom prst="rect">
              <a:avLst/>
            </a:prstGeom>
          </p:spPr>
        </p:pic>
        <p:pic>
          <p:nvPicPr>
            <p:cNvPr id="63" name="図 62"/>
            <p:cNvPicPr>
              <a:picLocks noChangeAspect="1"/>
            </p:cNvPicPr>
            <p:nvPr/>
          </p:nvPicPr>
          <p:blipFill rotWithShape="1">
            <a:blip r:embed="rId4"/>
            <a:srcRect l="5716" t="6345" r="6830" b="10111"/>
            <a:stretch/>
          </p:blipFill>
          <p:spPr>
            <a:xfrm>
              <a:off x="4516845" y="3858346"/>
              <a:ext cx="426245" cy="407194"/>
            </a:xfrm>
            <a:prstGeom prst="rect">
              <a:avLst/>
            </a:prstGeom>
          </p:spPr>
        </p:pic>
        <p:pic>
          <p:nvPicPr>
            <p:cNvPr id="64" name="図 63"/>
            <p:cNvPicPr>
              <a:picLocks noChangeAspect="1"/>
            </p:cNvPicPr>
            <p:nvPr/>
          </p:nvPicPr>
          <p:blipFill rotWithShape="1">
            <a:blip r:embed="rId4"/>
            <a:srcRect l="5716" t="6345" r="6830" b="10111"/>
            <a:stretch/>
          </p:blipFill>
          <p:spPr>
            <a:xfrm>
              <a:off x="7607513" y="3858346"/>
              <a:ext cx="426245" cy="407194"/>
            </a:xfrm>
            <a:prstGeom prst="rect">
              <a:avLst/>
            </a:prstGeom>
          </p:spPr>
        </p:pic>
        <p:pic>
          <p:nvPicPr>
            <p:cNvPr id="65" name="図 6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21551" y="3574545"/>
              <a:ext cx="487398" cy="487398"/>
            </a:xfrm>
            <a:prstGeom prst="rect">
              <a:avLst/>
            </a:prstGeom>
          </p:spPr>
        </p:pic>
        <p:pic>
          <p:nvPicPr>
            <p:cNvPr id="66" name="図 6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21551" y="5414359"/>
              <a:ext cx="487398" cy="487398"/>
            </a:xfrm>
            <a:prstGeom prst="rect">
              <a:avLst/>
            </a:prstGeom>
          </p:spPr>
        </p:pic>
        <p:pic>
          <p:nvPicPr>
            <p:cNvPr id="67" name="図 66"/>
            <p:cNvPicPr>
              <a:picLocks noChangeAspect="1"/>
            </p:cNvPicPr>
            <p:nvPr/>
          </p:nvPicPr>
          <p:blipFill rotWithShape="1">
            <a:blip r:embed="rId4"/>
            <a:srcRect l="5716" t="6345" r="6830" b="10111"/>
            <a:stretch/>
          </p:blipFill>
          <p:spPr>
            <a:xfrm>
              <a:off x="4549192" y="5661891"/>
              <a:ext cx="426245" cy="407194"/>
            </a:xfrm>
            <a:prstGeom prst="rect">
              <a:avLst/>
            </a:prstGeom>
          </p:spPr>
        </p:pic>
        <p:pic>
          <p:nvPicPr>
            <p:cNvPr id="68" name="図 67"/>
            <p:cNvPicPr>
              <a:picLocks noChangeAspect="1"/>
            </p:cNvPicPr>
            <p:nvPr/>
          </p:nvPicPr>
          <p:blipFill rotWithShape="1">
            <a:blip r:embed="rId4"/>
            <a:srcRect l="5716" t="6345" r="6830" b="10111"/>
            <a:stretch/>
          </p:blipFill>
          <p:spPr>
            <a:xfrm>
              <a:off x="7607513" y="5655850"/>
              <a:ext cx="426245" cy="407194"/>
            </a:xfrm>
            <a:prstGeom prst="rect">
              <a:avLst/>
            </a:prstGeom>
          </p:spPr>
        </p:pic>
        <p:sp>
          <p:nvSpPr>
            <p:cNvPr id="69" name="テキスト ボックス 68"/>
            <p:cNvSpPr txBox="1"/>
            <p:nvPr/>
          </p:nvSpPr>
          <p:spPr>
            <a:xfrm>
              <a:off x="3440045" y="3958163"/>
              <a:ext cx="1043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1</a:t>
              </a:r>
              <a:endParaRPr kumimoji="1" lang="ja-JP" altLang="en-US" sz="1600" b="1" dirty="0"/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3484863" y="5752629"/>
              <a:ext cx="1043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1</a:t>
              </a:r>
              <a:endParaRPr kumimoji="1" lang="ja-JP" altLang="en-US" sz="1600" b="1" dirty="0"/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8167881" y="3941656"/>
              <a:ext cx="1043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2</a:t>
              </a:r>
              <a:endParaRPr kumimoji="1" lang="ja-JP" altLang="en-US" sz="1600" b="1" dirty="0"/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8167881" y="5757400"/>
              <a:ext cx="104336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Stranger 3</a:t>
              </a:r>
              <a:endParaRPr kumimoji="1" lang="ja-JP" altLang="en-US" sz="1600" b="1" dirty="0"/>
            </a:p>
          </p:txBody>
        </p:sp>
        <p:cxnSp>
          <p:nvCxnSpPr>
            <p:cNvPr id="76" name="直線矢印コネクタ 75"/>
            <p:cNvCxnSpPr/>
            <p:nvPr/>
          </p:nvCxnSpPr>
          <p:spPr>
            <a:xfrm flipH="1">
              <a:off x="6291476" y="2963711"/>
              <a:ext cx="1900" cy="36155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矢印コネクタ 76"/>
            <p:cNvCxnSpPr/>
            <p:nvPr/>
          </p:nvCxnSpPr>
          <p:spPr>
            <a:xfrm flipH="1">
              <a:off x="6265250" y="4358658"/>
              <a:ext cx="1900" cy="75583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テキスト ボックス 79"/>
            <p:cNvSpPr txBox="1"/>
            <p:nvPr/>
          </p:nvSpPr>
          <p:spPr>
            <a:xfrm>
              <a:off x="1074544" y="3831251"/>
              <a:ext cx="26754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solidFill>
                    <a:srgbClr val="FF0000"/>
                  </a:solidFill>
                </a:rPr>
                <a:t>Social preference </a:t>
              </a:r>
              <a:r>
                <a:rPr kumimoji="1" lang="en-US" altLang="ja-JP" b="1" dirty="0"/>
                <a:t>: 5 min</a:t>
              </a:r>
              <a:endParaRPr kumimoji="1" lang="ja-JP" altLang="en-US" b="1" dirty="0"/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1140457" y="5627811"/>
              <a:ext cx="2260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solidFill>
                    <a:srgbClr val="FF0000"/>
                  </a:solidFill>
                </a:rPr>
                <a:t>Social memory</a:t>
              </a:r>
              <a:r>
                <a:rPr kumimoji="1" lang="en-US" altLang="ja-JP" b="1" dirty="0"/>
                <a:t>: 5 min</a:t>
              </a:r>
              <a:endParaRPr kumimoji="1" lang="ja-JP" altLang="en-US" b="1" dirty="0"/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6419568" y="2960843"/>
              <a:ext cx="17899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/>
                <a:t>immediately</a:t>
              </a:r>
              <a:endParaRPr kumimoji="1" lang="ja-JP" altLang="en-US" b="1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6291476" y="4578462"/>
              <a:ext cx="2227900" cy="377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/>
                <a:t>30 min interval</a:t>
              </a:r>
              <a:endParaRPr kumimoji="1" lang="ja-JP" altLang="en-US" b="1" dirty="0"/>
            </a:p>
          </p:txBody>
        </p:sp>
      </p:grpSp>
      <p:sp>
        <p:nvSpPr>
          <p:cNvPr id="12" name="テキスト ボックス 11"/>
          <p:cNvSpPr txBox="1"/>
          <p:nvPr/>
        </p:nvSpPr>
        <p:spPr>
          <a:xfrm>
            <a:off x="1361440" y="5537200"/>
            <a:ext cx="97840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Supplementary Figure 1</a:t>
            </a:r>
          </a:p>
          <a:p>
            <a:r>
              <a:rPr kumimoji="1" lang="en-US" altLang="ja-JP" sz="2400" dirty="0"/>
              <a:t>A scheme of the social behavioral test of sociability, social preference and social memory in the three-chamber box test.</a:t>
            </a:r>
            <a:endParaRPr kumimoji="1" lang="ja-JP" altLang="en-US" sz="2400" dirty="0"/>
          </a:p>
        </p:txBody>
      </p:sp>
    </p:spTree>
    <p:extLst>
      <p:ext uri="{BB962C8B-B14F-4D97-AF65-F5344CB8AC3E}">
        <p14:creationId xmlns:p14="http://schemas.microsoft.com/office/powerpoint/2010/main" val="1337903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5</TotalTime>
  <Words>80</Words>
  <Application>Microsoft Office PowerPoint</Application>
  <PresentationFormat>ワイド画面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Gerasimenko</dc:creator>
  <cp:lastModifiedBy>東田 陽博</cp:lastModifiedBy>
  <cp:revision>6</cp:revision>
  <cp:lastPrinted>2023-01-27T00:42:38Z</cp:lastPrinted>
  <dcterms:created xsi:type="dcterms:W3CDTF">2023-01-08T19:08:11Z</dcterms:created>
  <dcterms:modified xsi:type="dcterms:W3CDTF">2023-02-15T07:47:39Z</dcterms:modified>
</cp:coreProperties>
</file>